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69" r:id="rId2"/>
    <p:sldId id="364" r:id="rId3"/>
    <p:sldId id="358" r:id="rId4"/>
    <p:sldId id="361" r:id="rId5"/>
    <p:sldId id="351" r:id="rId6"/>
    <p:sldId id="363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72" autoAdjust="0"/>
    <p:restoredTop sz="92686" autoAdjust="0"/>
  </p:normalViewPr>
  <p:slideViewPr>
    <p:cSldViewPr snapToGrid="0">
      <p:cViewPr varScale="1">
        <p:scale>
          <a:sx n="71" d="100"/>
          <a:sy n="71" d="100"/>
        </p:scale>
        <p:origin x="9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59C9D9-BA38-4FDB-8DA8-6E9E0223F4C8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0B8D82-5AE6-4E73-9BFD-2F2A1C0C02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11765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0B8D82-5AE6-4E73-9BFD-2F2A1C0C024B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47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3B0DF8-B7A7-49B2-B5AA-853912DCEE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878F8F7-8D60-41BF-8165-62CD397D38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677EE3-CF52-48A6-880B-BAF7769A6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C8171D-A49A-41B8-9DCB-C74D21D47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39D1B7-40CD-4F20-9640-DDF409882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6102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7BCB73-2147-473A-BEAA-61721B295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07D8B0-7A03-4B85-ABC0-628DCCE29D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B673E6-718D-4124-8D64-83D3F588C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953E59-FEFD-4AB0-A4D0-B487A3595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155F1A-B03A-482D-A07A-CE7239476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2283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2B7A825-D283-4933-9ABE-CC23AE0881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749315-5ED8-495B-957E-D40AF75432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5B6586-BC05-4A6A-A76B-FF5E23EF1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6984A4-7409-4CA8-8575-90A818900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F51653-36B4-484B-A8BC-02159BD61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464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7F6923-5FA9-4BD0-98E9-DB796E8184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DC383B7-A47B-49FB-B953-7260861B3F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851EF7-572B-4C4F-8AAF-1A77BED64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8CF05D-94F5-4872-BA3F-22985B573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4F1FFD-01B8-461D-A03A-E5A41B7F4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089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AA4CDF-DA9B-4CE5-8879-FEA724F5E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518834-3C8D-4142-B794-82C32AB14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7649F3-1E90-4444-8852-66C63CA8A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174A3B-EC09-4F21-A2B1-F3792E51A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0BAEF9-4927-4EE5-8066-EAEC92E52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956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DDD5C0-CC62-4FDB-9F4E-52083CE28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A09B86-8A64-4066-AFCB-E97614E806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1327EDD-8E04-4C49-BBFB-9193115C83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C68465-A227-4006-B069-3A6939283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279884-E481-448D-877F-8DFC5D596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B70B1C5-87C9-48A8-8908-972E37135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45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64C8AD-4219-49AD-9B9B-C7B757EE5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8F6C87-D5FB-4C2A-BCB8-DCFDC77209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A33B2AD-823C-4735-968B-D60F9E0C14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11775A6-29B9-4444-A18D-E6B5B2C00D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556B08-23AC-4A31-90E7-EE795BCD4C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A77D765-C348-4DDD-97AE-7A9E5FFDC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AEF3293-4253-48D9-AA64-C3C5A9E0F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F7741E9-C56A-48B9-881B-E0F86ECF9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559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A6A4FD-29C5-4839-82E4-96BBDD28B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A6877B2-0A82-4773-A105-3FBFC52C2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AF0B463-DFC0-4CB2-A69A-0FE2EF0E7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0E1A0B0-54F9-4D06-8DA3-A12763930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814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F065018-320F-4D5C-8420-D67333040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FDB4426-D0F8-4A67-BCAF-5EF9ECF38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1C9D36B-68A8-4554-8E2D-C419CA149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135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BF5C4D-2B7B-4E3C-A12B-BBD36E23A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B34BE5-2A06-4714-96BE-1B506DAA94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9C18F9-86D9-4BE5-9ABA-B8A4B1DE8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3D8585-BFFF-4FA8-B74F-05B99BE9A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066A02-9983-45BB-8AAC-0FA29B7D2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B3BE7E-20DC-46C0-A8AD-BB31B689E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964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6D338F-DEF4-4E4C-8846-965D96A8CC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208942A-C849-44C7-A488-30E2A2D5CD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CEB1930-176D-421B-8F2D-C8856730B2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D6796A-3174-4E5B-99BF-CA85DC8B9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FEB605-893C-4C00-97B9-D6EC74AE7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3F4767-CED3-4A30-BEB2-BBBC77F4D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038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BB7F4BC-1980-4393-8488-56B582636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7424A5-850E-4F86-BFED-F693F99418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E171E1-DD76-40F4-BBB3-48E17F76A9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C195D-5073-46DA-A2C1-2ADEB862273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E91661-EF4B-4184-B67D-CB3655659C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6D4946-BB72-499D-B542-F8B2E1748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A9196-DF6B-4846-BEE2-9C80760DA9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233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30218A-E9C7-411B-95DD-170812B959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584173"/>
            <a:ext cx="10515600" cy="3592789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altLang="zh-CN" sz="5400" dirty="0"/>
              <a:t>Supplementary materials</a:t>
            </a:r>
            <a:endParaRPr lang="zh-CN" altLang="en-US" sz="5400" dirty="0"/>
          </a:p>
        </p:txBody>
      </p:sp>
    </p:spTree>
    <p:extLst>
      <p:ext uri="{BB962C8B-B14F-4D97-AF65-F5344CB8AC3E}">
        <p14:creationId xmlns:p14="http://schemas.microsoft.com/office/powerpoint/2010/main" val="4121214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5CFC744-43A4-4B2A-A95B-8E44F70AC785}"/>
              </a:ext>
            </a:extLst>
          </p:cNvPr>
          <p:cNvSpPr txBox="1"/>
          <p:nvPr/>
        </p:nvSpPr>
        <p:spPr>
          <a:xfrm>
            <a:off x="494467" y="5754211"/>
            <a:ext cx="112030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igure S1. </a:t>
            </a:r>
            <a:r>
              <a:rPr lang="en-US" altLang="zh-CN" sz="1200" b="1" dirty="0"/>
              <a:t>Mutation at position V17 to E of KS20 peptide enhances the activation of BDC5.2.9. </a:t>
            </a:r>
            <a:r>
              <a:rPr lang="en-US" altLang="zh-CN" sz="1200" dirty="0"/>
              <a:t>M12C3</a:t>
            </a:r>
            <a:r>
              <a:rPr lang="en-US" altLang="zh-CN" sz="1200" baseline="30000" dirty="0"/>
              <a:t>G7</a:t>
            </a:r>
            <a:r>
              <a:rPr lang="en-US" altLang="zh-CN" sz="1200" dirty="0"/>
              <a:t> B cell line (1×10</a:t>
            </a:r>
            <a:r>
              <a:rPr lang="en-US" altLang="zh-CN" sz="1200" baseline="30000" dirty="0"/>
              <a:t>5</a:t>
            </a:r>
            <a:r>
              <a:rPr lang="en-US" altLang="zh-CN" sz="1200" dirty="0"/>
              <a:t>/well) were used as antigen-presenting cells and cultured with different concentrations of KS20 peptide or KS20V17E peptide. Then add BDC5.2.9 (1×10</a:t>
            </a:r>
            <a:r>
              <a:rPr lang="en-US" altLang="zh-CN" sz="1200" baseline="30000" dirty="0"/>
              <a:t>5</a:t>
            </a:r>
            <a:r>
              <a:rPr lang="en-US" altLang="zh-CN" sz="1200" dirty="0"/>
              <a:t>/well). 20-24 h later, culture supernatants were then harvested, and secreted IL-2 was measured by IL-2 assay. </a:t>
            </a:r>
            <a:endParaRPr lang="zh-CN" altLang="zh-CN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C1FB216-780B-4588-8C62-C623B9BB31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8191" y="1102874"/>
            <a:ext cx="6760464" cy="4392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0728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862D11-7C4C-48AE-B374-FD725D826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BC3C9BA-07DC-45F5-BE6D-21CEB1D3A357}"/>
              </a:ext>
            </a:extLst>
          </p:cNvPr>
          <p:cNvSpPr txBox="1"/>
          <p:nvPr/>
        </p:nvSpPr>
        <p:spPr>
          <a:xfrm>
            <a:off x="326535" y="5835241"/>
            <a:ext cx="112030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igure S2. </a:t>
            </a:r>
            <a:r>
              <a:rPr lang="en-US" altLang="zh-CN" sz="1200" b="1" dirty="0"/>
              <a:t>Serum levels of LD96.24 in different groups. </a:t>
            </a:r>
            <a:r>
              <a:rPr lang="en-US" altLang="zh-CN" sz="1200" dirty="0"/>
              <a:t>Serum samples in different groups were collected every 2 weeks with 3-d delay after antibody treatment. LD96.24 was measured by using IA</a:t>
            </a:r>
            <a:r>
              <a:rPr lang="en-US" altLang="zh-CN" sz="1200" baseline="30000" dirty="0"/>
              <a:t>g7</a:t>
            </a:r>
            <a:r>
              <a:rPr lang="en-US" altLang="zh-CN" sz="1200" dirty="0"/>
              <a:t>-KS20 coated plates as described in Materials and methods.</a:t>
            </a:r>
            <a:endParaRPr lang="zh-CN" altLang="zh-CN" sz="12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9B78A08-4D64-4940-B33E-F20810628B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5558" y="1577829"/>
            <a:ext cx="8557497" cy="44882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611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967E1CCF-748C-4ACE-AC83-AC232C433061}"/>
              </a:ext>
            </a:extLst>
          </p:cNvPr>
          <p:cNvSpPr txBox="1"/>
          <p:nvPr/>
        </p:nvSpPr>
        <p:spPr>
          <a:xfrm>
            <a:off x="1705258" y="5927149"/>
            <a:ext cx="81225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igure S3. Related to Fig 4. </a:t>
            </a:r>
            <a:r>
              <a:rPr lang="en-US" altLang="zh-CN" sz="1200" b="1" dirty="0"/>
              <a:t>Blood glucose levels of individual mice in each group.</a:t>
            </a:r>
            <a:r>
              <a:rPr lang="en-US" altLang="zh-CN" sz="1200" dirty="0"/>
              <a:t> Blood glucose of each mouse was measured weekly in PBS group </a:t>
            </a:r>
            <a:r>
              <a:rPr lang="en-US" altLang="zh-CN" sz="1200" b="1" dirty="0"/>
              <a:t>(A)</a:t>
            </a:r>
            <a:r>
              <a:rPr lang="en-US" altLang="zh-CN" sz="1200" dirty="0"/>
              <a:t>, isotype control A111.3 group </a:t>
            </a:r>
            <a:r>
              <a:rPr lang="en-US" altLang="zh-CN" sz="1200" b="1" dirty="0"/>
              <a:t>(B)</a:t>
            </a:r>
            <a:r>
              <a:rPr lang="en-US" altLang="zh-CN" sz="1200" dirty="0"/>
              <a:t> or LD96.24 group </a:t>
            </a:r>
            <a:r>
              <a:rPr lang="en-US" altLang="zh-CN" sz="1200" b="1" dirty="0"/>
              <a:t>(C)</a:t>
            </a:r>
            <a:r>
              <a:rPr lang="en-US" altLang="zh-CN" sz="1200" dirty="0"/>
              <a:t>. </a:t>
            </a:r>
            <a:endParaRPr lang="zh-CN" altLang="zh-CN" sz="120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89279F7-EC9C-4071-A1D1-45CDE09220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5258" y="469186"/>
            <a:ext cx="7427462" cy="5359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17530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E69EEBF-563F-4B35-A9F0-7274AC32CAC5}"/>
              </a:ext>
            </a:extLst>
          </p:cNvPr>
          <p:cNvSpPr txBox="1"/>
          <p:nvPr/>
        </p:nvSpPr>
        <p:spPr>
          <a:xfrm>
            <a:off x="317252" y="5232734"/>
            <a:ext cx="115574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igure S4. related to Fig 5. </a:t>
            </a:r>
            <a:r>
              <a:rPr lang="en-US" altLang="zh-CN" sz="1200" b="1" dirty="0"/>
              <a:t>Treatment with LD96.24 has no effect on distributions of T cells and APCs in the spleen.</a:t>
            </a:r>
            <a:r>
              <a:rPr lang="en-US" altLang="zh-CN" sz="1200" dirty="0"/>
              <a:t> 4w female NOD mice (n=5) were treated with PBS, 0.5 mg LD96.24 or control antibody A111.3 weekly and sacrificed at 10wk of age. Splenocytes were prepared and stained with antibodies of B220, CD11c, and CD11b. (</a:t>
            </a:r>
            <a:r>
              <a:rPr lang="en-US" altLang="zh-CN" sz="1200" b="1" dirty="0"/>
              <a:t>A)</a:t>
            </a:r>
            <a:r>
              <a:rPr lang="en-US" altLang="zh-CN" sz="1200" dirty="0"/>
              <a:t> The mean fluorescence intensities of IA</a:t>
            </a:r>
            <a:r>
              <a:rPr lang="en-US" altLang="zh-CN" sz="1200" baseline="30000" dirty="0"/>
              <a:t>g7</a:t>
            </a:r>
            <a:r>
              <a:rPr lang="en-US" altLang="zh-CN" sz="1200" dirty="0"/>
              <a:t> in B cells. </a:t>
            </a:r>
            <a:r>
              <a:rPr lang="en-US" altLang="zh-CN" sz="1200" b="1" dirty="0"/>
              <a:t>(B-D)</a:t>
            </a:r>
            <a:r>
              <a:rPr lang="en-US" altLang="zh-CN" sz="1200" dirty="0"/>
              <a:t> The percentages of B220+ </a:t>
            </a:r>
            <a:r>
              <a:rPr lang="en-US" altLang="zh-CN" sz="1200" b="1" dirty="0"/>
              <a:t>(B)</a:t>
            </a:r>
            <a:r>
              <a:rPr lang="en-US" altLang="zh-CN" sz="1200" dirty="0"/>
              <a:t>, CD11c+ </a:t>
            </a:r>
            <a:r>
              <a:rPr lang="en-US" altLang="zh-CN" sz="1200" b="1" dirty="0"/>
              <a:t>(C) </a:t>
            </a:r>
            <a:r>
              <a:rPr lang="en-US" altLang="zh-CN" sz="1200" dirty="0"/>
              <a:t>and CD11b+ </a:t>
            </a:r>
            <a:r>
              <a:rPr lang="en-US" altLang="zh-CN" sz="1200" b="1" dirty="0"/>
              <a:t>(D)</a:t>
            </a:r>
            <a:r>
              <a:rPr lang="en-US" altLang="zh-CN" sz="1200" dirty="0"/>
              <a:t> in total splenocytes are shown. Data are means ± SEM of each group. </a:t>
            </a:r>
            <a:endParaRPr lang="zh-CN" altLang="zh-CN" sz="1200" dirty="0"/>
          </a:p>
          <a:p>
            <a:endParaRPr lang="zh-CN" altLang="en-US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689A7D-5301-4D70-820C-1F0D90D2EE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9103" y="517725"/>
            <a:ext cx="4811268" cy="4255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34240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45D096C-A9E8-4508-B95F-5E3D4F32D6D1}"/>
              </a:ext>
            </a:extLst>
          </p:cNvPr>
          <p:cNvSpPr txBox="1"/>
          <p:nvPr/>
        </p:nvSpPr>
        <p:spPr>
          <a:xfrm>
            <a:off x="613972" y="5820121"/>
            <a:ext cx="109640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S5</a:t>
            </a:r>
            <a:r>
              <a:rPr lang="en-US" altLang="zh-CN" sz="1200" dirty="0"/>
              <a:t>, related to Fig 7. The impact of LD96.24 on CD4+IFN-γ+ and CD8+IFN-γ+ in spleen. The animal experiment is the same as Fig 7. described. The splenocytes were isolated for staining. </a:t>
            </a:r>
            <a:r>
              <a:rPr lang="en-US" altLang="zh-CN" sz="1200" b="1" dirty="0"/>
              <a:t>(A)</a:t>
            </a:r>
            <a:r>
              <a:rPr lang="en-US" altLang="zh-CN" sz="1200" dirty="0"/>
              <a:t> Representative scatter diagram of CD4+IFN-γ+ and CD8+IFN-γ+ in different groups. </a:t>
            </a:r>
            <a:r>
              <a:rPr lang="en-US" altLang="zh-CN" sz="1200" b="1" dirty="0"/>
              <a:t>(B and C) </a:t>
            </a:r>
            <a:r>
              <a:rPr lang="en-US" altLang="zh-CN" sz="1200" dirty="0"/>
              <a:t>The percentages and cell numbers of CD4+IFN-γ+ T cells in the spleen. </a:t>
            </a:r>
            <a:r>
              <a:rPr lang="en-US" altLang="zh-CN" sz="1200" b="1" dirty="0"/>
              <a:t>(D and E)</a:t>
            </a:r>
            <a:r>
              <a:rPr lang="en-US" altLang="zh-CN" sz="1200" dirty="0"/>
              <a:t> The percentages and cell numbers of CD8+IFN-γ+ T cells in the spleen. Data are means ± SEM of each group. Statistical analysis was performed using one-way ANOVA with Tukey’s multiple comparisons test. *P &lt; 0.05, ** P&lt; 0.001, *** P&lt; 0.0001.</a:t>
            </a:r>
            <a:endParaRPr lang="zh-CN" altLang="zh-CN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DB23784-D51C-4D4F-B365-33458C6018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3480" y="323384"/>
            <a:ext cx="7220283" cy="5220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2682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1</TotalTime>
  <Words>424</Words>
  <Application>Microsoft Office PowerPoint</Application>
  <PresentationFormat>Widescreen</PresentationFormat>
  <Paragraphs>7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 anti IAg7–IAPP monoclonal antibody  modulates type 1 diabetes</dc:title>
  <dc:creator>Administrator</dc:creator>
  <cp:lastModifiedBy>Li, Wei</cp:lastModifiedBy>
  <cp:revision>253</cp:revision>
  <dcterms:created xsi:type="dcterms:W3CDTF">2020-02-11T23:20:21Z</dcterms:created>
  <dcterms:modified xsi:type="dcterms:W3CDTF">2022-06-19T00:25:17Z</dcterms:modified>
</cp:coreProperties>
</file>